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89" r:id="rId2"/>
    <p:sldId id="286" r:id="rId3"/>
    <p:sldId id="287" r:id="rId4"/>
  </p:sldIdLst>
  <p:sldSz cx="6858000" cy="9144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F10E0"/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1415" autoAdjust="0"/>
  </p:normalViewPr>
  <p:slideViewPr>
    <p:cSldViewPr>
      <p:cViewPr varScale="1">
        <p:scale>
          <a:sx n="86" d="100"/>
          <a:sy n="86" d="100"/>
        </p:scale>
        <p:origin x="2928" y="96"/>
      </p:cViewPr>
      <p:guideLst>
        <p:guide orient="horz" pos="2880"/>
        <p:guide pos="2160"/>
      </p:guideLst>
    </p:cSldViewPr>
  </p:slideViewPr>
  <p:notesTextViewPr>
    <p:cViewPr>
      <p:scale>
        <a:sx n="150" d="100"/>
        <a:sy n="15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rthik Suresh" userId="aa6094d9-4557-4166-92f0-1a4591607a21" providerId="ADAL" clId="{3947E4F2-8B6B-4169-9DB4-9CAC6D302E2B}"/>
    <pc:docChg chg="modSld">
      <pc:chgData name="Karthik Suresh" userId="aa6094d9-4557-4166-92f0-1a4591607a21" providerId="ADAL" clId="{3947E4F2-8B6B-4169-9DB4-9CAC6D302E2B}" dt="2021-02-15T17:57:47.089" v="7" actId="20577"/>
      <pc:docMkLst>
        <pc:docMk/>
      </pc:docMkLst>
      <pc:sldChg chg="modSp mod">
        <pc:chgData name="Karthik Suresh" userId="aa6094d9-4557-4166-92f0-1a4591607a21" providerId="ADAL" clId="{3947E4F2-8B6B-4169-9DB4-9CAC6D302E2B}" dt="2021-02-15T17:57:47.089" v="7" actId="20577"/>
        <pc:sldMkLst>
          <pc:docMk/>
          <pc:sldMk cId="3104269108" sldId="287"/>
        </pc:sldMkLst>
        <pc:spChg chg="mod">
          <ac:chgData name="Karthik Suresh" userId="aa6094d9-4557-4166-92f0-1a4591607a21" providerId="ADAL" clId="{3947E4F2-8B6B-4169-9DB4-9CAC6D302E2B}" dt="2021-02-15T17:57:32.717" v="1" actId="20577"/>
          <ac:spMkLst>
            <pc:docMk/>
            <pc:sldMk cId="3104269108" sldId="287"/>
            <ac:spMk id="7" creationId="{00000000-0000-0000-0000-000000000000}"/>
          </ac:spMkLst>
        </pc:spChg>
        <pc:spChg chg="mod">
          <ac:chgData name="Karthik Suresh" userId="aa6094d9-4557-4166-92f0-1a4591607a21" providerId="ADAL" clId="{3947E4F2-8B6B-4169-9DB4-9CAC6D302E2B}" dt="2021-02-15T17:57:37.730" v="3" actId="20577"/>
          <ac:spMkLst>
            <pc:docMk/>
            <pc:sldMk cId="3104269108" sldId="287"/>
            <ac:spMk id="8" creationId="{00000000-0000-0000-0000-000000000000}"/>
          </ac:spMkLst>
        </pc:spChg>
        <pc:spChg chg="mod">
          <ac:chgData name="Karthik Suresh" userId="aa6094d9-4557-4166-92f0-1a4591607a21" providerId="ADAL" clId="{3947E4F2-8B6B-4169-9DB4-9CAC6D302E2B}" dt="2021-02-15T17:57:42.793" v="5" actId="20577"/>
          <ac:spMkLst>
            <pc:docMk/>
            <pc:sldMk cId="3104269108" sldId="287"/>
            <ac:spMk id="10" creationId="{00000000-0000-0000-0000-000000000000}"/>
          </ac:spMkLst>
        </pc:spChg>
        <pc:spChg chg="mod">
          <ac:chgData name="Karthik Suresh" userId="aa6094d9-4557-4166-92f0-1a4591607a21" providerId="ADAL" clId="{3947E4F2-8B6B-4169-9DB4-9CAC6D302E2B}" dt="2021-02-15T17:57:47.089" v="7" actId="20577"/>
          <ac:spMkLst>
            <pc:docMk/>
            <pc:sldMk cId="3104269108" sldId="287"/>
            <ac:spMk id="12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A7C054-5F89-4ED9-8EBE-DDF45ECDA0AA}" type="datetimeFigureOut">
              <a:rPr lang="en-US" smtClean="0"/>
              <a:t>2/1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696913"/>
            <a:ext cx="2613025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5790"/>
            <a:ext cx="5486400" cy="418338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078988-D265-49FD-9E32-67B075B215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7910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3078988-D265-49FD-9E32-67B075B2157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48908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63B7F-E12F-411A-824E-77DFD87469A0}" type="datetimeFigureOut">
              <a:rPr lang="en-US" smtClean="0"/>
              <a:t>2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AC836-3A32-40B1-A0C9-4CF6A20E0E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6651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63B7F-E12F-411A-824E-77DFD87469A0}" type="datetimeFigureOut">
              <a:rPr lang="en-US" smtClean="0"/>
              <a:t>2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AC836-3A32-40B1-A0C9-4CF6A20E0E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869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63B7F-E12F-411A-824E-77DFD87469A0}" type="datetimeFigureOut">
              <a:rPr lang="en-US" smtClean="0"/>
              <a:t>2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AC836-3A32-40B1-A0C9-4CF6A20E0E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638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63B7F-E12F-411A-824E-77DFD87469A0}" type="datetimeFigureOut">
              <a:rPr lang="en-US" smtClean="0"/>
              <a:t>2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AC836-3A32-40B1-A0C9-4CF6A20E0E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0636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63B7F-E12F-411A-824E-77DFD87469A0}" type="datetimeFigureOut">
              <a:rPr lang="en-US" smtClean="0"/>
              <a:t>2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AC836-3A32-40B1-A0C9-4CF6A20E0E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4654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63B7F-E12F-411A-824E-77DFD87469A0}" type="datetimeFigureOut">
              <a:rPr lang="en-US" smtClean="0"/>
              <a:t>2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AC836-3A32-40B1-A0C9-4CF6A20E0E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5602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63B7F-E12F-411A-824E-77DFD87469A0}" type="datetimeFigureOut">
              <a:rPr lang="en-US" smtClean="0"/>
              <a:t>2/1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AC836-3A32-40B1-A0C9-4CF6A20E0E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310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63B7F-E12F-411A-824E-77DFD87469A0}" type="datetimeFigureOut">
              <a:rPr lang="en-US" smtClean="0"/>
              <a:t>2/1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AC836-3A32-40B1-A0C9-4CF6A20E0E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920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63B7F-E12F-411A-824E-77DFD87469A0}" type="datetimeFigureOut">
              <a:rPr lang="en-US" smtClean="0"/>
              <a:t>2/1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AC836-3A32-40B1-A0C9-4CF6A20E0E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0020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63B7F-E12F-411A-824E-77DFD87469A0}" type="datetimeFigureOut">
              <a:rPr lang="en-US" smtClean="0"/>
              <a:t>2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AC836-3A32-40B1-A0C9-4CF6A20E0E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724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63B7F-E12F-411A-824E-77DFD87469A0}" type="datetimeFigureOut">
              <a:rPr lang="en-US" smtClean="0"/>
              <a:t>2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AC836-3A32-40B1-A0C9-4CF6A20E0E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3071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663B7F-E12F-411A-824E-77DFD87469A0}" type="datetimeFigureOut">
              <a:rPr lang="en-US" smtClean="0"/>
              <a:t>2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4AC836-3A32-40B1-A0C9-4CF6A20E0E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930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Group 49"/>
          <p:cNvGrpSpPr/>
          <p:nvPr/>
        </p:nvGrpSpPr>
        <p:grpSpPr>
          <a:xfrm>
            <a:off x="0" y="412714"/>
            <a:ext cx="3107432" cy="2326490"/>
            <a:chOff x="0" y="412714"/>
            <a:chExt cx="3107432" cy="2326490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C42BB052-6772-4A55-A9E5-56EE33B1E56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22623" y="412714"/>
              <a:ext cx="2884809" cy="2163607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/>
          </p:nvSpPr>
          <p:spPr>
            <a:xfrm>
              <a:off x="569051" y="914400"/>
              <a:ext cx="3453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11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52C490BE-1BC6-48C5-9FD0-C26E6EC9A044}"/>
                </a:ext>
              </a:extLst>
            </p:cNvPr>
            <p:cNvCxnSpPr/>
            <p:nvPr/>
          </p:nvCxnSpPr>
          <p:spPr>
            <a:xfrm>
              <a:off x="684746" y="1246004"/>
              <a:ext cx="0" cy="18288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231D0BC9-CCCD-49E5-9ED9-1831A5E2D48F}"/>
                </a:ext>
              </a:extLst>
            </p:cNvPr>
            <p:cNvSpPr txBox="1"/>
            <p:nvPr/>
          </p:nvSpPr>
          <p:spPr>
            <a:xfrm>
              <a:off x="0" y="462359"/>
              <a:ext cx="54392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812906" y="2477594"/>
              <a:ext cx="17042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ime (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hr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03257" y="762000"/>
              <a:ext cx="353943" cy="129540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ER (R/R</a:t>
              </a:r>
              <a:r>
                <a:rPr lang="en-US" sz="11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3936257" y="0"/>
            <a:ext cx="29217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  <p:grpSp>
        <p:nvGrpSpPr>
          <p:cNvPr id="46" name="Group 45"/>
          <p:cNvGrpSpPr/>
          <p:nvPr/>
        </p:nvGrpSpPr>
        <p:grpSpPr>
          <a:xfrm>
            <a:off x="3011456" y="414447"/>
            <a:ext cx="3041230" cy="2328753"/>
            <a:chOff x="3011456" y="414447"/>
            <a:chExt cx="3041230" cy="2328753"/>
          </a:xfrm>
        </p:grpSpPr>
        <p:grpSp>
          <p:nvGrpSpPr>
            <p:cNvPr id="44" name="Group 43"/>
            <p:cNvGrpSpPr/>
            <p:nvPr/>
          </p:nvGrpSpPr>
          <p:grpSpPr>
            <a:xfrm>
              <a:off x="3011456" y="414447"/>
              <a:ext cx="3041230" cy="2328753"/>
              <a:chOff x="3011456" y="414447"/>
              <a:chExt cx="3041230" cy="2328753"/>
            </a:xfrm>
          </p:grpSpPr>
          <p:grpSp>
            <p:nvGrpSpPr>
              <p:cNvPr id="17" name="Group 16"/>
              <p:cNvGrpSpPr/>
              <p:nvPr/>
            </p:nvGrpSpPr>
            <p:grpSpPr>
              <a:xfrm>
                <a:off x="3011456" y="414447"/>
                <a:ext cx="3041230" cy="2130556"/>
                <a:chOff x="3723272" y="2206989"/>
                <a:chExt cx="3041230" cy="2130556"/>
              </a:xfrm>
            </p:grpSpPr>
            <p:pic>
              <p:nvPicPr>
                <p:cNvPr id="9" name="Picture 8">
                  <a:extLst>
                    <a:ext uri="{FF2B5EF4-FFF2-40B4-BE49-F238E27FC236}">
                      <a16:creationId xmlns:a16="http://schemas.microsoft.com/office/drawing/2014/main" id="{B24045CD-A328-4496-8F98-BFE47B78258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3945895" y="2223590"/>
                  <a:ext cx="2818607" cy="2113955"/>
                </a:xfrm>
                <a:prstGeom prst="rect">
                  <a:avLst/>
                </a:prstGeom>
              </p:spPr>
            </p:pic>
            <p:sp>
              <p:nvSpPr>
                <p:cNvPr id="10" name="TextBox 9"/>
                <p:cNvSpPr txBox="1"/>
                <p:nvPr/>
              </p:nvSpPr>
              <p:spPr>
                <a:xfrm>
                  <a:off x="4405067" y="2706942"/>
                  <a:ext cx="345349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r>
                    <a:rPr lang="en-US" sz="11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cxnSp>
              <p:nvCxnSpPr>
                <p:cNvPr id="25" name="Straight Arrow Connector 24">
                  <a:extLst>
                    <a:ext uri="{FF2B5EF4-FFF2-40B4-BE49-F238E27FC236}">
                      <a16:creationId xmlns:a16="http://schemas.microsoft.com/office/drawing/2014/main" id="{6B5A2835-5163-48F4-A394-15C4A75472D2}"/>
                    </a:ext>
                  </a:extLst>
                </p:cNvPr>
                <p:cNvCxnSpPr/>
                <p:nvPr/>
              </p:nvCxnSpPr>
              <p:spPr>
                <a:xfrm>
                  <a:off x="4532072" y="3127521"/>
                  <a:ext cx="0" cy="18288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66E5501B-EA48-4A30-963A-9FD6C0CB1980}"/>
                    </a:ext>
                  </a:extLst>
                </p:cNvPr>
                <p:cNvSpPr txBox="1"/>
                <p:nvPr/>
              </p:nvSpPr>
              <p:spPr>
                <a:xfrm>
                  <a:off x="3723272" y="2206989"/>
                  <a:ext cx="543928" cy="3693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9" name="TextBox 38"/>
              <p:cNvSpPr txBox="1"/>
              <p:nvPr/>
            </p:nvSpPr>
            <p:spPr>
              <a:xfrm>
                <a:off x="3934558" y="2481590"/>
                <a:ext cx="170424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Time (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r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</p:grpSp>
        <p:sp>
          <p:nvSpPr>
            <p:cNvPr id="35" name="TextBox 34"/>
            <p:cNvSpPr txBox="1"/>
            <p:nvPr/>
          </p:nvSpPr>
          <p:spPr>
            <a:xfrm>
              <a:off x="3151257" y="762000"/>
              <a:ext cx="353943" cy="129540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ER (R/R</a:t>
              </a:r>
              <a:r>
                <a:rPr lang="en-US" sz="11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grpSp>
        <p:nvGrpSpPr>
          <p:cNvPr id="51" name="Group 50"/>
          <p:cNvGrpSpPr/>
          <p:nvPr/>
        </p:nvGrpSpPr>
        <p:grpSpPr>
          <a:xfrm>
            <a:off x="0" y="2585971"/>
            <a:ext cx="2957977" cy="2400039"/>
            <a:chOff x="0" y="2585971"/>
            <a:chExt cx="2957977" cy="2400039"/>
          </a:xfrm>
        </p:grpSpPr>
        <p:grpSp>
          <p:nvGrpSpPr>
            <p:cNvPr id="18" name="Group 17"/>
            <p:cNvGrpSpPr/>
            <p:nvPr/>
          </p:nvGrpSpPr>
          <p:grpSpPr>
            <a:xfrm>
              <a:off x="0" y="2585971"/>
              <a:ext cx="2957977" cy="2172332"/>
              <a:chOff x="3723272" y="4275845"/>
              <a:chExt cx="2957977" cy="2172332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A43E18DB-C030-4978-AFAB-BAC6A1E939B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942729" y="4394287"/>
                <a:ext cx="2738520" cy="2053890"/>
              </a:xfrm>
              <a:prstGeom prst="rect">
                <a:avLst/>
              </a:prstGeom>
            </p:spPr>
          </p:pic>
          <p:sp>
            <p:nvSpPr>
              <p:cNvPr id="11" name="TextBox 10"/>
              <p:cNvSpPr txBox="1"/>
              <p:nvPr/>
            </p:nvSpPr>
            <p:spPr>
              <a:xfrm>
                <a:off x="4597123" y="4933464"/>
                <a:ext cx="34534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sz="11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4" name="Straight Arrow Connector 23">
                <a:extLst>
                  <a:ext uri="{FF2B5EF4-FFF2-40B4-BE49-F238E27FC236}">
                    <a16:creationId xmlns:a16="http://schemas.microsoft.com/office/drawing/2014/main" id="{937B059A-7253-4D30-A9DB-484D62206747}"/>
                  </a:ext>
                </a:extLst>
              </p:cNvPr>
              <p:cNvCxnSpPr/>
              <p:nvPr/>
            </p:nvCxnSpPr>
            <p:spPr>
              <a:xfrm>
                <a:off x="4750218" y="5332798"/>
                <a:ext cx="0" cy="18288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A1120217-00AA-4040-BE37-F1B7CF5CA11B}"/>
                  </a:ext>
                </a:extLst>
              </p:cNvPr>
              <p:cNvSpPr txBox="1"/>
              <p:nvPr/>
            </p:nvSpPr>
            <p:spPr>
              <a:xfrm>
                <a:off x="3723272" y="4275845"/>
                <a:ext cx="543928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1" name="TextBox 40"/>
            <p:cNvSpPr txBox="1"/>
            <p:nvPr/>
          </p:nvSpPr>
          <p:spPr>
            <a:xfrm>
              <a:off x="838200" y="4724400"/>
              <a:ext cx="17042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ime (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hr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03257" y="3048000"/>
              <a:ext cx="353943" cy="129540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ER (R/R</a:t>
              </a:r>
              <a:r>
                <a:rPr lang="en-US" sz="11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grpSp>
        <p:nvGrpSpPr>
          <p:cNvPr id="23" name="Group 22"/>
          <p:cNvGrpSpPr/>
          <p:nvPr/>
        </p:nvGrpSpPr>
        <p:grpSpPr>
          <a:xfrm>
            <a:off x="0" y="4891114"/>
            <a:ext cx="2941935" cy="2424086"/>
            <a:chOff x="0" y="5305124"/>
            <a:chExt cx="2941935" cy="2424086"/>
          </a:xfrm>
        </p:grpSpPr>
        <p:grpSp>
          <p:nvGrpSpPr>
            <p:cNvPr id="21" name="Group 20"/>
            <p:cNvGrpSpPr/>
            <p:nvPr/>
          </p:nvGrpSpPr>
          <p:grpSpPr>
            <a:xfrm>
              <a:off x="0" y="5305124"/>
              <a:ext cx="2941935" cy="2238676"/>
              <a:chOff x="0" y="5305124"/>
              <a:chExt cx="2941935" cy="2238676"/>
            </a:xfrm>
          </p:grpSpPr>
          <p:grpSp>
            <p:nvGrpSpPr>
              <p:cNvPr id="20" name="Group 19"/>
              <p:cNvGrpSpPr/>
              <p:nvPr/>
            </p:nvGrpSpPr>
            <p:grpSpPr>
              <a:xfrm>
                <a:off x="0" y="5305124"/>
                <a:ext cx="2941935" cy="2238676"/>
                <a:chOff x="3772605" y="8362704"/>
                <a:chExt cx="2941935" cy="2197745"/>
              </a:xfrm>
            </p:grpSpPr>
            <p:pic>
              <p:nvPicPr>
                <p:cNvPr id="3" name="Picture 2">
                  <a:extLst>
                    <a:ext uri="{FF2B5EF4-FFF2-40B4-BE49-F238E27FC236}">
                      <a16:creationId xmlns:a16="http://schemas.microsoft.com/office/drawing/2014/main" id="{A79C1DE4-0285-492B-BBA4-E8F4FE7088F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3953459" y="8489638"/>
                  <a:ext cx="2761081" cy="2070811"/>
                </a:xfrm>
                <a:prstGeom prst="rect">
                  <a:avLst/>
                </a:prstGeom>
              </p:spPr>
            </p:pic>
            <p:sp>
              <p:nvSpPr>
                <p:cNvPr id="13" name="TextBox 12"/>
                <p:cNvSpPr txBox="1"/>
                <p:nvPr/>
              </p:nvSpPr>
              <p:spPr>
                <a:xfrm>
                  <a:off x="5296605" y="8928192"/>
                  <a:ext cx="345349" cy="2568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r>
                    <a:rPr lang="en-US" sz="11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cxnSp>
              <p:nvCxnSpPr>
                <p:cNvPr id="4" name="Straight Arrow Connector 3"/>
                <p:cNvCxnSpPr/>
                <p:nvPr/>
              </p:nvCxnSpPr>
              <p:spPr>
                <a:xfrm>
                  <a:off x="5439478" y="9293224"/>
                  <a:ext cx="0" cy="179536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46001496-06FD-42FA-B699-714EBCED6428}"/>
                    </a:ext>
                  </a:extLst>
                </p:cNvPr>
                <p:cNvSpPr txBox="1"/>
                <p:nvPr/>
              </p:nvSpPr>
              <p:spPr>
                <a:xfrm>
                  <a:off x="3772605" y="8362704"/>
                  <a:ext cx="543928" cy="3693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8" name="TextBox 37"/>
              <p:cNvSpPr txBox="1"/>
              <p:nvPr/>
            </p:nvSpPr>
            <p:spPr>
              <a:xfrm>
                <a:off x="103257" y="5791200"/>
                <a:ext cx="353943" cy="1295400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TER (R/R</a:t>
                </a:r>
                <a:r>
                  <a:rPr lang="en-US" sz="11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</p:grpSp>
        <p:sp>
          <p:nvSpPr>
            <p:cNvPr id="42" name="TextBox 41"/>
            <p:cNvSpPr txBox="1"/>
            <p:nvPr/>
          </p:nvSpPr>
          <p:spPr>
            <a:xfrm>
              <a:off x="838200" y="7467600"/>
              <a:ext cx="17042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ime (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hr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grpSp>
        <p:nvGrpSpPr>
          <p:cNvPr id="47" name="Group 46"/>
          <p:cNvGrpSpPr/>
          <p:nvPr/>
        </p:nvGrpSpPr>
        <p:grpSpPr>
          <a:xfrm>
            <a:off x="2978030" y="2660635"/>
            <a:ext cx="3051095" cy="2325375"/>
            <a:chOff x="2978030" y="2660635"/>
            <a:chExt cx="3051095" cy="2325375"/>
          </a:xfrm>
        </p:grpSpPr>
        <p:grpSp>
          <p:nvGrpSpPr>
            <p:cNvPr id="28" name="Group 27"/>
            <p:cNvGrpSpPr/>
            <p:nvPr/>
          </p:nvGrpSpPr>
          <p:grpSpPr>
            <a:xfrm>
              <a:off x="2978030" y="2660635"/>
              <a:ext cx="3051095" cy="2325375"/>
              <a:chOff x="2978030" y="2660635"/>
              <a:chExt cx="3051095" cy="2325375"/>
            </a:xfrm>
          </p:grpSpPr>
          <p:grpSp>
            <p:nvGrpSpPr>
              <p:cNvPr id="19" name="Group 18"/>
              <p:cNvGrpSpPr/>
              <p:nvPr/>
            </p:nvGrpSpPr>
            <p:grpSpPr>
              <a:xfrm>
                <a:off x="2978030" y="2660635"/>
                <a:ext cx="3051095" cy="2141445"/>
                <a:chOff x="3670765" y="6298109"/>
                <a:chExt cx="3051095" cy="2141445"/>
              </a:xfrm>
            </p:grpSpPr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2D49A088-256E-4E12-B1B2-B87E8983EFA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3976707" y="6380689"/>
                  <a:ext cx="2745153" cy="2058865"/>
                </a:xfrm>
                <a:prstGeom prst="rect">
                  <a:avLst/>
                </a:prstGeom>
              </p:spPr>
            </p:pic>
            <p:cxnSp>
              <p:nvCxnSpPr>
                <p:cNvPr id="6" name="Straight Arrow Connector 5"/>
                <p:cNvCxnSpPr/>
                <p:nvPr/>
              </p:nvCxnSpPr>
              <p:spPr>
                <a:xfrm>
                  <a:off x="5017618" y="7257721"/>
                  <a:ext cx="0" cy="18288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" name="TextBox 11"/>
                <p:cNvSpPr txBox="1"/>
                <p:nvPr/>
              </p:nvSpPr>
              <p:spPr>
                <a:xfrm>
                  <a:off x="4843186" y="6881064"/>
                  <a:ext cx="345349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r>
                    <a:rPr lang="en-US" sz="11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BA4A1045-0279-43B0-BB97-4D8060B07E30}"/>
                    </a:ext>
                  </a:extLst>
                </p:cNvPr>
                <p:cNvSpPr txBox="1"/>
                <p:nvPr/>
              </p:nvSpPr>
              <p:spPr>
                <a:xfrm>
                  <a:off x="3670765" y="6298109"/>
                  <a:ext cx="543928" cy="3693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0" name="TextBox 39"/>
              <p:cNvSpPr txBox="1"/>
              <p:nvPr/>
            </p:nvSpPr>
            <p:spPr>
              <a:xfrm>
                <a:off x="3934558" y="4724400"/>
                <a:ext cx="170424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Time (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r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</p:grpSp>
        <p:sp>
          <p:nvSpPr>
            <p:cNvPr id="37" name="TextBox 36"/>
            <p:cNvSpPr txBox="1"/>
            <p:nvPr/>
          </p:nvSpPr>
          <p:spPr>
            <a:xfrm>
              <a:off x="3124200" y="3048000"/>
              <a:ext cx="353943" cy="129540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ER (R/R</a:t>
              </a:r>
              <a:r>
                <a:rPr lang="en-US" sz="11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855411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6542DFB4-1B9A-45D9-96D8-A210AB8C843D}"/>
              </a:ext>
            </a:extLst>
          </p:cNvPr>
          <p:cNvSpPr txBox="1"/>
          <p:nvPr/>
        </p:nvSpPr>
        <p:spPr>
          <a:xfrm>
            <a:off x="3936257" y="11668"/>
            <a:ext cx="29217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  <p:grpSp>
        <p:nvGrpSpPr>
          <p:cNvPr id="14" name="Group 13"/>
          <p:cNvGrpSpPr/>
          <p:nvPr/>
        </p:nvGrpSpPr>
        <p:grpSpPr>
          <a:xfrm>
            <a:off x="304800" y="533400"/>
            <a:ext cx="1983748" cy="3690610"/>
            <a:chOff x="533400" y="533400"/>
            <a:chExt cx="1983748" cy="3690610"/>
          </a:xfrm>
        </p:grpSpPr>
        <p:grpSp>
          <p:nvGrpSpPr>
            <p:cNvPr id="2" name="Group 1"/>
            <p:cNvGrpSpPr/>
            <p:nvPr/>
          </p:nvGrpSpPr>
          <p:grpSpPr>
            <a:xfrm>
              <a:off x="533400" y="533400"/>
              <a:ext cx="1905000" cy="3680298"/>
              <a:chOff x="1752600" y="533400"/>
              <a:chExt cx="1905000" cy="3680298"/>
            </a:xfrm>
          </p:grpSpPr>
          <p:pic>
            <p:nvPicPr>
              <p:cNvPr id="1026" name="Picture 1">
                <a:extLst>
                  <a:ext uri="{FF2B5EF4-FFF2-40B4-BE49-F238E27FC236}">
                    <a16:creationId xmlns:a16="http://schemas.microsoft.com/office/drawing/2014/main" id="{67BF27DE-8D18-48D6-90D8-39D242BDE10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64221"/>
              <a:stretch/>
            </p:blipFill>
            <p:spPr bwMode="auto">
              <a:xfrm>
                <a:off x="1752600" y="533400"/>
                <a:ext cx="1752600" cy="368029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cxnSp>
            <p:nvCxnSpPr>
              <p:cNvPr id="3" name="Straight Connector 2"/>
              <p:cNvCxnSpPr/>
              <p:nvPr/>
            </p:nvCxnSpPr>
            <p:spPr>
              <a:xfrm>
                <a:off x="2636520" y="26670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Straight Connector 6"/>
              <p:cNvCxnSpPr/>
              <p:nvPr/>
            </p:nvCxnSpPr>
            <p:spPr>
              <a:xfrm>
                <a:off x="2636520" y="2438400"/>
                <a:ext cx="182880" cy="0"/>
              </a:xfrm>
              <a:prstGeom prst="line">
                <a:avLst/>
              </a:prstGeom>
              <a:ln w="19050"/>
            </p:spPr>
            <p:style>
              <a:lnRef idx="1">
                <a:schemeClr val="accent6"/>
              </a:lnRef>
              <a:fillRef idx="0">
                <a:schemeClr val="accent6"/>
              </a:fillRef>
              <a:effectRef idx="0">
                <a:schemeClr val="accent6"/>
              </a:effectRef>
              <a:fontRef idx="minor">
                <a:schemeClr val="tx1"/>
              </a:fontRef>
            </p:style>
          </p:cxnSp>
          <p:sp>
            <p:nvSpPr>
              <p:cNvPr id="5" name="TextBox 4"/>
              <p:cNvSpPr txBox="1"/>
              <p:nvPr/>
            </p:nvSpPr>
            <p:spPr>
              <a:xfrm>
                <a:off x="2819400" y="2307595"/>
                <a:ext cx="8382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 Narrow" panose="020B0606020202030204" pitchFamily="34" charset="0"/>
                  </a:rPr>
                  <a:t>Actual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2819400" y="2536195"/>
                <a:ext cx="8382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 Narrow" panose="020B0606020202030204" pitchFamily="34" charset="0"/>
                  </a:rPr>
                  <a:t>Fitted</a:t>
                </a:r>
              </a:p>
            </p:txBody>
          </p:sp>
        </p:grpSp>
        <p:sp>
          <p:nvSpPr>
            <p:cNvPr id="10" name="TextBox 9"/>
            <p:cNvSpPr txBox="1"/>
            <p:nvPr/>
          </p:nvSpPr>
          <p:spPr>
            <a:xfrm>
              <a:off x="609600" y="1676400"/>
              <a:ext cx="353943" cy="129540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ER (R/R</a:t>
              </a:r>
              <a:r>
                <a:rPr lang="en-US" sz="11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812906" y="3962400"/>
              <a:ext cx="17042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ime (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hr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197643" y="4466360"/>
            <a:ext cx="3719513" cy="2362199"/>
            <a:chOff x="1752600" y="4876801"/>
            <a:chExt cx="3719513" cy="2362199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4CC5391-941B-497C-9005-DE4906022E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11287"/>
            <a:stretch/>
          </p:blipFill>
          <p:spPr>
            <a:xfrm>
              <a:off x="1752600" y="4876801"/>
              <a:ext cx="3719513" cy="2133600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2334358" y="6977390"/>
              <a:ext cx="17042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429000" y="6977390"/>
              <a:ext cx="17042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FTY720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231D0BC9-CCCD-49E5-9ED9-1831A5E2D48F}"/>
              </a:ext>
            </a:extLst>
          </p:cNvPr>
          <p:cNvSpPr txBox="1"/>
          <p:nvPr/>
        </p:nvSpPr>
        <p:spPr>
          <a:xfrm>
            <a:off x="141872" y="462359"/>
            <a:ext cx="5439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31D0BC9-CCCD-49E5-9ED9-1831A5E2D48F}"/>
              </a:ext>
            </a:extLst>
          </p:cNvPr>
          <p:cNvSpPr txBox="1"/>
          <p:nvPr/>
        </p:nvSpPr>
        <p:spPr>
          <a:xfrm>
            <a:off x="141872" y="4114800"/>
            <a:ext cx="5439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3698012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BEED772D-A1F7-4F41-A2CE-5E52376998D1}"/>
              </a:ext>
            </a:extLst>
          </p:cNvPr>
          <p:cNvSpPr txBox="1"/>
          <p:nvPr/>
        </p:nvSpPr>
        <p:spPr>
          <a:xfrm>
            <a:off x="3936257" y="11668"/>
            <a:ext cx="29217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</a:p>
        </p:txBody>
      </p:sp>
      <p:grpSp>
        <p:nvGrpSpPr>
          <p:cNvPr id="13" name="Group 12"/>
          <p:cNvGrpSpPr/>
          <p:nvPr/>
        </p:nvGrpSpPr>
        <p:grpSpPr>
          <a:xfrm>
            <a:off x="533400" y="762000"/>
            <a:ext cx="3581400" cy="3820666"/>
            <a:chOff x="533400" y="762000"/>
            <a:chExt cx="3581400" cy="3820666"/>
          </a:xfrm>
        </p:grpSpPr>
        <p:sp>
          <p:nvSpPr>
            <p:cNvPr id="7" name="TextBox 6"/>
            <p:cNvSpPr txBox="1"/>
            <p:nvPr/>
          </p:nvSpPr>
          <p:spPr>
            <a:xfrm rot="18515988">
              <a:off x="563499" y="3526927"/>
              <a:ext cx="184986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Original - 100s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 rot="18515988">
              <a:off x="973538" y="3526927"/>
              <a:ext cx="184986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Original - 200s</a:t>
              </a:r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533400" y="762000"/>
              <a:ext cx="3581400" cy="3326767"/>
              <a:chOff x="533400" y="762000"/>
              <a:chExt cx="3581400" cy="3326767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F29E529A-7D14-4323-A70E-E93CC6E771A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8510" b="22916"/>
              <a:stretch/>
            </p:blipFill>
            <p:spPr>
              <a:xfrm>
                <a:off x="838200" y="770021"/>
                <a:ext cx="3276600" cy="2125579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84CC5391-941B-497C-9005-DE4906022ED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r="91805"/>
              <a:stretch/>
            </p:blipFill>
            <p:spPr>
              <a:xfrm>
                <a:off x="533400" y="762000"/>
                <a:ext cx="304800" cy="2405063"/>
              </a:xfrm>
              <a:prstGeom prst="rect">
                <a:avLst/>
              </a:prstGeom>
            </p:spPr>
          </p:pic>
          <p:sp>
            <p:nvSpPr>
              <p:cNvPr id="3" name="TextBox 2"/>
              <p:cNvSpPr txBox="1"/>
              <p:nvPr/>
            </p:nvSpPr>
            <p:spPr>
              <a:xfrm rot="18515988">
                <a:off x="556494" y="3310262"/>
                <a:ext cx="12954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Original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 rot="18515988">
                <a:off x="1881906" y="3310262"/>
                <a:ext cx="12954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Original</a:t>
                </a:r>
              </a:p>
            </p:txBody>
          </p:sp>
        </p:grpSp>
        <p:sp>
          <p:nvSpPr>
            <p:cNvPr id="10" name="TextBox 9"/>
            <p:cNvSpPr txBox="1"/>
            <p:nvPr/>
          </p:nvSpPr>
          <p:spPr>
            <a:xfrm rot="18515988">
              <a:off x="1811738" y="3526927"/>
              <a:ext cx="184986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Original - 100s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 rot="18515988">
              <a:off x="2268938" y="3526927"/>
              <a:ext cx="184986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Original - 200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042691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822</TotalTime>
  <Words>100</Words>
  <Application>Microsoft Office PowerPoint</Application>
  <PresentationFormat>On-screen Show (4:3)</PresentationFormat>
  <Paragraphs>38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Arial Narrow</vt:lpstr>
      <vt:lpstr>Calibri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endra Damarla</dc:creator>
  <cp:lastModifiedBy>Karthik Suresh</cp:lastModifiedBy>
  <cp:revision>470</cp:revision>
  <cp:lastPrinted>2014-10-28T19:27:27Z</cp:lastPrinted>
  <dcterms:created xsi:type="dcterms:W3CDTF">2014-06-24T15:20:31Z</dcterms:created>
  <dcterms:modified xsi:type="dcterms:W3CDTF">2021-02-15T17:58:05Z</dcterms:modified>
</cp:coreProperties>
</file>